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186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761198477044148"/>
          <c:y val="0.20502911872316057"/>
          <c:w val="0.64081214909029038"/>
          <c:h val="0.567677452574802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</c:f>
              <c:strCache>
                <c:ptCount val="1"/>
                <c:pt idx="0">
                  <c:v>MEF2C</c:v>
                </c:pt>
              </c:strCache>
            </c:strRef>
          </c:cat>
          <c:val>
            <c:numRef>
              <c:f>Sheet1!$B$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CTRLs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</c:f>
              <c:strCache>
                <c:ptCount val="1"/>
                <c:pt idx="0">
                  <c:v>MEF2C</c:v>
                </c:pt>
              </c:strCache>
            </c:strRef>
          </c:cat>
          <c:val>
            <c:numRef>
              <c:f>Sheet1!$B$3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CX3CR1s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</c:f>
              <c:strCache>
                <c:ptCount val="1"/>
                <c:pt idx="0">
                  <c:v>MEF2C</c:v>
                </c:pt>
              </c:strCache>
            </c:strRef>
          </c:cat>
          <c:val>
            <c:numRef>
              <c:f>Sheet1!$B$4</c:f>
              <c:numCache>
                <c:formatCode>General</c:formatCode>
                <c:ptCount val="1"/>
                <c:pt idx="0">
                  <c:v>0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4176384"/>
        <c:axId val="144176944"/>
      </c:barChart>
      <c:catAx>
        <c:axId val="14417638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4176944"/>
        <c:crosses val="autoZero"/>
        <c:auto val="1"/>
        <c:lblAlgn val="ctr"/>
        <c:lblOffset val="100"/>
        <c:tickLblSkip val="1"/>
        <c:noMultiLvlLbl val="0"/>
      </c:catAx>
      <c:valAx>
        <c:axId val="144176944"/>
        <c:scaling>
          <c:orientation val="minMax"/>
          <c:max val="1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orm.MEF2C</a:t>
                </a:r>
              </a:p>
            </c:rich>
          </c:tx>
          <c:layout>
            <c:manualLayout>
              <c:xMode val="edge"/>
              <c:yMode val="edge"/>
              <c:x val="0.1007605082278933"/>
              <c:y val="8.632804998869918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417638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0274812605730214"/>
          <c:y val="3.8918146394019575E-2"/>
          <c:w val="0.73444845742978715"/>
          <c:h val="0.1517563849619255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60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99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20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802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400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130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7385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618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431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05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0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42063-AFCD-4AD5-B300-36B6DD04246C}" type="datetimeFigureOut">
              <a:rPr lang="en-US" smtClean="0"/>
              <a:t>2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8BB6B-74B0-4918-8709-09F8E81685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298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chart" Target="../charts/chart1.xml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27246" y="2775442"/>
            <a:ext cx="2312075" cy="1723837"/>
            <a:chOff x="-27246" y="3301883"/>
            <a:chExt cx="2312075" cy="172383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/>
            <a:srcRect l="9344" t="7371" r="30041" b="10431"/>
            <a:stretch/>
          </p:blipFill>
          <p:spPr>
            <a:xfrm>
              <a:off x="459670" y="3458927"/>
              <a:ext cx="1740734" cy="1234179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109058" y="3445853"/>
              <a:ext cx="1140737" cy="477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</a:p>
            <a:p>
              <a:pPr algn="r">
                <a:lnSpc>
                  <a:spcPts val="10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223</a:t>
              </a:r>
            </a:p>
            <a:p>
              <a:pPr algn="r">
                <a:lnSpc>
                  <a:spcPts val="1000"/>
                </a:lnSpc>
              </a:pP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grank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es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74188" y="4641227"/>
              <a:ext cx="18756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40      80      120   16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65554" y="4779499"/>
              <a:ext cx="9936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3750" y="3396154"/>
              <a:ext cx="476610" cy="13875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 algn="r">
                <a:lnSpc>
                  <a:spcPts val="1400"/>
                </a:lnSpc>
              </a:pP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400"/>
                </a:lnSpc>
              </a:pP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  <a:p>
              <a:pPr algn="r">
                <a:lnSpc>
                  <a:spcPts val="1400"/>
                </a:lnSpc>
              </a:pP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400"/>
                </a:lnSpc>
              </a:pPr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17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-658960" y="3933597"/>
              <a:ext cx="15096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viving Fraction, %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ight Bracket 10"/>
            <p:cNvSpPr/>
            <p:nvPr/>
          </p:nvSpPr>
          <p:spPr>
            <a:xfrm>
              <a:off x="2045073" y="4527848"/>
              <a:ext cx="45719" cy="110557"/>
            </a:xfrm>
            <a:prstGeom prst="rightBracket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51124" y="4493081"/>
              <a:ext cx="905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1225697" y="3986639"/>
              <a:ext cx="1059132" cy="553998"/>
              <a:chOff x="7230544" y="1128889"/>
              <a:chExt cx="1059132" cy="553998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7439385" y="1128889"/>
                <a:ext cx="850291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900"/>
                  </a:lnSpc>
                </a:pP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F2C        alteration</a:t>
                </a:r>
              </a:p>
              <a:p>
                <a:pPr>
                  <a:lnSpc>
                    <a:spcPts val="900"/>
                  </a:lnSpc>
                </a:pP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F2C NO alteration 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>
                <a:off x="7236189" y="1219200"/>
                <a:ext cx="259644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7230544" y="1428045"/>
                <a:ext cx="259644" cy="0"/>
              </a:xfrm>
              <a:prstGeom prst="line">
                <a:avLst/>
              </a:prstGeom>
              <a:ln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17" name="Tabl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8000124"/>
              </p:ext>
            </p:extLst>
          </p:nvPr>
        </p:nvGraphicFramePr>
        <p:xfrm>
          <a:off x="2319640" y="2931756"/>
          <a:ext cx="4536822" cy="14184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95839"/>
                <a:gridCol w="536309"/>
                <a:gridCol w="938541"/>
                <a:gridCol w="966133"/>
              </a:tblGrid>
              <a:tr h="270181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SURVIVAL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case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cases deceased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survival, </a:t>
                      </a:r>
                      <a:r>
                        <a:rPr lang="en-US" sz="10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270181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s: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39044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 alteration (upregulation) in MEF2C expression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.84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43904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out alteration in MEF2C expres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8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48</a:t>
                      </a:r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grpSp>
        <p:nvGrpSpPr>
          <p:cNvPr id="18" name="Group 17"/>
          <p:cNvGrpSpPr/>
          <p:nvPr/>
        </p:nvGrpSpPr>
        <p:grpSpPr>
          <a:xfrm>
            <a:off x="47047" y="4908835"/>
            <a:ext cx="2526677" cy="2145568"/>
            <a:chOff x="-195135" y="7172095"/>
            <a:chExt cx="2526677" cy="2145568"/>
          </a:xfrm>
        </p:grpSpPr>
        <p:graphicFrame>
          <p:nvGraphicFramePr>
            <p:cNvPr id="19" name="Chart 18"/>
            <p:cNvGraphicFramePr/>
            <p:nvPr>
              <p:extLst>
                <p:ext uri="{D42A27DB-BD31-4B8C-83A1-F6EECF244321}">
                  <p14:modId xmlns:p14="http://schemas.microsoft.com/office/powerpoint/2010/main" val="457723494"/>
                </p:ext>
              </p:extLst>
            </p:nvPr>
          </p:nvGraphicFramePr>
          <p:xfrm>
            <a:off x="-153453" y="8048476"/>
            <a:ext cx="2268746" cy="12691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20" name="Picture 6" descr="C:\Users\jsacks3\Desktop\SKOV3_siCX3_MEF2C_2.jpg"/>
            <p:cNvPicPr>
              <a:picLocks noChangeAspect="1" noChangeArrowheads="1"/>
            </p:cNvPicPr>
            <p:nvPr/>
          </p:nvPicPr>
          <p:blipFill rotWithShape="1">
            <a:blip r:embed="rId4">
              <a:lum bright="-1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91" t="49188" r="30826" b="41211"/>
            <a:stretch/>
          </p:blipFill>
          <p:spPr bwMode="auto">
            <a:xfrm>
              <a:off x="518780" y="7428204"/>
              <a:ext cx="1453249" cy="25610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TextBox 20"/>
            <p:cNvSpPr txBox="1"/>
            <p:nvPr/>
          </p:nvSpPr>
          <p:spPr>
            <a:xfrm>
              <a:off x="-188697" y="7730562"/>
              <a:ext cx="7819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-195135" y="7425678"/>
              <a:ext cx="7819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35971" y="7172095"/>
              <a:ext cx="17955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    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TRL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Picture 2" descr="C:\Users\jsacks3\Desktop\OVCAR4_siCX3_MEF2C_MycN_betaactin_1min_exp.jpg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85" t="38528" r="46982" b="41909"/>
            <a:stretch/>
          </p:blipFill>
          <p:spPr bwMode="auto">
            <a:xfrm>
              <a:off x="517664" y="7756002"/>
              <a:ext cx="1454365" cy="18084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TextBox 24"/>
            <p:cNvSpPr txBox="1"/>
            <p:nvPr/>
          </p:nvSpPr>
          <p:spPr>
            <a:xfrm>
              <a:off x="1476481" y="8576166"/>
              <a:ext cx="191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187544" y="448851"/>
            <a:ext cx="2493561" cy="2115856"/>
            <a:chOff x="2406211" y="252151"/>
            <a:chExt cx="2493561" cy="2115856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6"/>
            <a:srcRect l="19594" t="2228" r="16888" b="18664"/>
            <a:stretch/>
          </p:blipFill>
          <p:spPr>
            <a:xfrm>
              <a:off x="2949912" y="397331"/>
              <a:ext cx="1470172" cy="1469332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2941370" y="420576"/>
              <a:ext cx="166664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0.613</a:t>
              </a:r>
            </a:p>
            <a:p>
              <a:pPr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0.613</a:t>
              </a:r>
            </a:p>
            <a:p>
              <a:pPr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&lt;0.00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694424" y="2019194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, </a:t>
              </a:r>
              <a:b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809791" y="1845344"/>
              <a:ext cx="20899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  -2   -1   0   1   2    3   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492269" y="339460"/>
              <a:ext cx="474302" cy="16312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  <a:p>
              <a:pPr algn="r">
                <a:lnSpc>
                  <a:spcPts val="1200"/>
                </a:lnSpc>
              </a:pPr>
              <a:r>
                <a:rPr lang="en-US" sz="1000" kern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1614758" y="1043604"/>
              <a:ext cx="1931720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</a:t>
              </a:r>
              <a:b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4733103" y="442114"/>
            <a:ext cx="2062713" cy="2103244"/>
            <a:chOff x="4733103" y="3196605"/>
            <a:chExt cx="2062713" cy="2103244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7"/>
            <a:srcRect l="19878" t="2419" r="16770" b="18634"/>
            <a:stretch/>
          </p:blipFill>
          <p:spPr>
            <a:xfrm>
              <a:off x="5163460" y="3339688"/>
              <a:ext cx="1466330" cy="1466342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5246285" y="4782761"/>
              <a:ext cx="72795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sease fre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702094" y="4782761"/>
              <a:ext cx="1008947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gressed/</a:t>
              </a:r>
              <a:b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curred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733103" y="3277356"/>
              <a:ext cx="500208" cy="180466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5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500"/>
                </a:lnSpc>
              </a:pP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982485" y="5053628"/>
              <a:ext cx="1813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sease free statu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Left Bracket 38"/>
            <p:cNvSpPr/>
            <p:nvPr/>
          </p:nvSpPr>
          <p:spPr>
            <a:xfrm rot="5400000">
              <a:off x="5840986" y="3264846"/>
              <a:ext cx="61515" cy="53475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477720" y="3289858"/>
              <a:ext cx="872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061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3915221" y="4114338"/>
              <a:ext cx="2056040" cy="220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level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488940" y="511374"/>
            <a:ext cx="2018998" cy="2056040"/>
            <a:chOff x="1530812" y="7111086"/>
            <a:chExt cx="2018998" cy="2056040"/>
          </a:xfrm>
        </p:grpSpPr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8"/>
            <a:srcRect l="19952" t="1685" r="17041" b="18707"/>
            <a:stretch/>
          </p:blipFill>
          <p:spPr>
            <a:xfrm>
              <a:off x="1958982" y="7181814"/>
              <a:ext cx="1458344" cy="1478619"/>
            </a:xfrm>
            <a:prstGeom prst="rect">
              <a:avLst/>
            </a:prstGeom>
          </p:spPr>
        </p:pic>
        <p:sp>
          <p:nvSpPr>
            <p:cNvPr id="44" name="Left Bracket 43"/>
            <p:cNvSpPr/>
            <p:nvPr/>
          </p:nvSpPr>
          <p:spPr>
            <a:xfrm rot="5400000">
              <a:off x="2672017" y="7071896"/>
              <a:ext cx="52621" cy="58346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260452" y="7135235"/>
              <a:ext cx="10039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02457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178653" y="8669603"/>
              <a:ext cx="450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757865" y="8654425"/>
              <a:ext cx="4502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667912" y="8911754"/>
              <a:ext cx="18818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scular invasion indicator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629983" y="7287985"/>
              <a:ext cx="401947" cy="15927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1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  <a:p>
              <a:pPr algn="r">
                <a:lnSpc>
                  <a:spcPts val="21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  <a:p>
              <a:pPr algn="r">
                <a:lnSpc>
                  <a:spcPts val="21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  <a:p>
              <a:pPr algn="r">
                <a:lnSpc>
                  <a:spcPts val="21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21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0.5</a:t>
              </a:r>
            </a:p>
            <a:p>
              <a:pPr algn="r"/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 rot="16200000">
              <a:off x="613079" y="8028819"/>
              <a:ext cx="2056040" cy="220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level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2680256" y="7083571"/>
            <a:ext cx="2022347" cy="2109259"/>
            <a:chOff x="5065568" y="4674915"/>
            <a:chExt cx="2022347" cy="2109259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9"/>
            <a:srcRect l="20296" t="2302" r="16754" b="18983"/>
            <a:stretch/>
          </p:blipFill>
          <p:spPr>
            <a:xfrm>
              <a:off x="5400989" y="4883499"/>
              <a:ext cx="1457011" cy="1462035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5421275" y="4900918"/>
              <a:ext cx="166664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-0.092</a:t>
              </a:r>
            </a:p>
            <a:p>
              <a:pPr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-0.131</a:t>
              </a:r>
            </a:p>
            <a:p>
              <a:pPr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374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305531" y="6300318"/>
              <a:ext cx="1752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    6    7    8    9   10  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098903" y="6435361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(RNA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2 RSEM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119456" y="4799428"/>
              <a:ext cx="353085" cy="144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4147835" y="5592648"/>
              <a:ext cx="2056040" cy="220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50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level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4816085" y="4785173"/>
            <a:ext cx="2014155" cy="2063654"/>
            <a:chOff x="2626040" y="4717443"/>
            <a:chExt cx="2014155" cy="2063654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10"/>
            <a:srcRect l="20148" t="2398" r="16902" b="18617"/>
            <a:stretch/>
          </p:blipFill>
          <p:spPr>
            <a:xfrm>
              <a:off x="2954215" y="4883499"/>
              <a:ext cx="1457012" cy="1467059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>
              <a:off x="2973555" y="4896959"/>
              <a:ext cx="166664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0.035</a:t>
              </a:r>
            </a:p>
            <a:p>
              <a:pPr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0.061</a:t>
              </a:r>
            </a:p>
            <a:p>
              <a:pPr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213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846974" y="6297178"/>
              <a:ext cx="17522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    6    7    8    9   10  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714538" y="6432284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(RNA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2 RSEM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684167" y="4906367"/>
              <a:ext cx="347697" cy="14487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  <a:p>
              <a:pPr algn="r">
                <a:lnSpc>
                  <a:spcPts val="18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1708307" y="5635176"/>
              <a:ext cx="2056040" cy="220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E11A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otein level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5" name="TextBox 64"/>
          <p:cNvSpPr txBox="1"/>
          <p:nvPr/>
        </p:nvSpPr>
        <p:spPr>
          <a:xfrm>
            <a:off x="0" y="0"/>
            <a:ext cx="401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ie, et al; Supplementary 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485" y="237066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519905" y="198352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3485" y="2528716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3485" y="4481693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548332" y="4481692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5903" y="7015371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77" name="Group 76"/>
          <p:cNvGrpSpPr/>
          <p:nvPr/>
        </p:nvGrpSpPr>
        <p:grpSpPr>
          <a:xfrm>
            <a:off x="4682119" y="6892082"/>
            <a:ext cx="2334959" cy="2291317"/>
            <a:chOff x="1035567" y="6809972"/>
            <a:chExt cx="2334959" cy="2291317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11"/>
            <a:srcRect l="20071" t="2311" r="16765" b="19264"/>
            <a:stretch/>
          </p:blipFill>
          <p:spPr>
            <a:xfrm>
              <a:off x="1573619" y="7187609"/>
              <a:ext cx="1461976" cy="1456661"/>
            </a:xfrm>
            <a:prstGeom prst="rect">
              <a:avLst/>
            </a:prstGeom>
          </p:spPr>
        </p:pic>
        <p:sp>
          <p:nvSpPr>
            <p:cNvPr id="71" name="TextBox 70"/>
            <p:cNvSpPr txBox="1"/>
            <p:nvPr/>
          </p:nvSpPr>
          <p:spPr>
            <a:xfrm>
              <a:off x="1379020" y="8591108"/>
              <a:ext cx="1991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istant Sensitive Too earl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322568" y="8735482"/>
              <a:ext cx="19915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ATINUM STATU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Left Bracket 72"/>
            <p:cNvSpPr/>
            <p:nvPr/>
          </p:nvSpPr>
          <p:spPr>
            <a:xfrm rot="5400000">
              <a:off x="2025842" y="7074614"/>
              <a:ext cx="45719" cy="531628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836048" y="7134449"/>
              <a:ext cx="4175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273544" y="7129132"/>
              <a:ext cx="369187" cy="15129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pPr algn="r">
                <a:lnSpc>
                  <a:spcPts val="14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 rot="16200000">
              <a:off x="89963" y="7755576"/>
              <a:ext cx="22913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, 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z-scor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Group 83"/>
          <p:cNvGrpSpPr/>
          <p:nvPr/>
        </p:nvGrpSpPr>
        <p:grpSpPr>
          <a:xfrm>
            <a:off x="2413324" y="4808568"/>
            <a:ext cx="2285621" cy="2043848"/>
            <a:chOff x="2413324" y="4797279"/>
            <a:chExt cx="2285621" cy="2043848"/>
          </a:xfrm>
        </p:grpSpPr>
        <p:pic>
          <p:nvPicPr>
            <p:cNvPr id="78" name="Picture 77"/>
            <p:cNvPicPr>
              <a:picLocks noChangeAspect="1"/>
            </p:cNvPicPr>
            <p:nvPr/>
          </p:nvPicPr>
          <p:blipFill rotWithShape="1">
            <a:blip r:embed="rId12"/>
            <a:srcRect l="20111" t="2601" r="16791" b="19003"/>
            <a:stretch/>
          </p:blipFill>
          <p:spPr>
            <a:xfrm>
              <a:off x="2994552" y="4949027"/>
              <a:ext cx="1460440" cy="1456107"/>
            </a:xfrm>
            <a:prstGeom prst="rect">
              <a:avLst/>
            </a:prstGeom>
          </p:spPr>
        </p:pic>
        <p:sp>
          <p:nvSpPr>
            <p:cNvPr id="79" name="TextBox 78"/>
            <p:cNvSpPr txBox="1"/>
            <p:nvPr/>
          </p:nvSpPr>
          <p:spPr>
            <a:xfrm>
              <a:off x="2832570" y="4960986"/>
              <a:ext cx="166664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-0.112</a:t>
              </a:r>
            </a:p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-0.114</a:t>
              </a:r>
            </a:p>
            <a:p>
              <a:pPr algn="r"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357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072558" y="6357001"/>
              <a:ext cx="1458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1000       20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811076" y="6492314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(RNA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2 RSEM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512063" y="4871595"/>
              <a:ext cx="562906" cy="1522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00</a:t>
              </a:r>
            </a:p>
            <a:p>
              <a:pPr algn="r"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0</a:t>
              </a:r>
            </a:p>
            <a:p>
              <a:pPr algn="r"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</a:p>
            <a:p>
              <a:pPr algn="r">
                <a:lnSpc>
                  <a:spcPts val="23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</a:p>
            <a:p>
              <a:pPr algn="r">
                <a:lnSpc>
                  <a:spcPts val="23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 rot="16200000">
              <a:off x="1643796" y="5566807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E11A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(RNA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2 RSEM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5" name="TextBox 84"/>
          <p:cNvSpPr txBox="1"/>
          <p:nvPr/>
        </p:nvSpPr>
        <p:spPr>
          <a:xfrm>
            <a:off x="4649997" y="7009725"/>
            <a:ext cx="3207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92" name="Group 91"/>
          <p:cNvGrpSpPr/>
          <p:nvPr/>
        </p:nvGrpSpPr>
        <p:grpSpPr>
          <a:xfrm>
            <a:off x="128360" y="7104300"/>
            <a:ext cx="2284964" cy="2072850"/>
            <a:chOff x="128360" y="7138167"/>
            <a:chExt cx="2284964" cy="2072850"/>
          </a:xfrm>
        </p:grpSpPr>
        <p:pic>
          <p:nvPicPr>
            <p:cNvPr id="86" name="Picture 85"/>
            <p:cNvPicPr>
              <a:picLocks noChangeAspect="1"/>
            </p:cNvPicPr>
            <p:nvPr/>
          </p:nvPicPr>
          <p:blipFill rotWithShape="1">
            <a:blip r:embed="rId13"/>
            <a:srcRect l="20117" t="2378" r="16808" b="19021"/>
            <a:stretch/>
          </p:blipFill>
          <p:spPr>
            <a:xfrm>
              <a:off x="748145" y="7315200"/>
              <a:ext cx="1459924" cy="1459923"/>
            </a:xfrm>
            <a:prstGeom prst="rect">
              <a:avLst/>
            </a:prstGeom>
          </p:spPr>
        </p:pic>
        <p:sp>
          <p:nvSpPr>
            <p:cNvPr id="87" name="TextBox 86"/>
            <p:cNvSpPr txBox="1"/>
            <p:nvPr/>
          </p:nvSpPr>
          <p:spPr>
            <a:xfrm>
              <a:off x="535384" y="7330690"/>
              <a:ext cx="1666640" cy="438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arson 0.021</a:t>
              </a:r>
            </a:p>
            <a:p>
              <a:pPr algn="r">
                <a:lnSpc>
                  <a:spcPts val="9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earman 0.022</a:t>
              </a:r>
            </a:p>
            <a:p>
              <a:pPr algn="r">
                <a:lnSpc>
                  <a:spcPts val="900"/>
                </a:lnSpc>
              </a:pPr>
              <a:r>
                <a:rPr lang="en-US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0.626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812309" y="8727865"/>
              <a:ext cx="14589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         1000       200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525455" y="8862204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F2C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(RNA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2 RSEM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61670" y="7391356"/>
              <a:ext cx="559527" cy="1371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26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</a:p>
            <a:p>
              <a:pPr algn="r">
                <a:lnSpc>
                  <a:spcPts val="26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  <a:p>
              <a:pPr algn="r">
                <a:lnSpc>
                  <a:spcPts val="2600"/>
                </a:lnSpc>
              </a:pP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  <a:p>
              <a:pPr algn="r">
                <a:lnSpc>
                  <a:spcPts val="26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 rot="16200000">
              <a:off x="-641168" y="7907695"/>
              <a:ext cx="1887869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ts val="1000"/>
                </a:lnSpc>
              </a:pP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D50,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NA expression (RNA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q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2 RSEM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52477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</TotalTime>
  <Words>317</Words>
  <Application>Microsoft Office PowerPoint</Application>
  <PresentationFormat>On-screen Show (4:3)</PresentationFormat>
  <Paragraphs>14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12</cp:revision>
  <cp:lastPrinted>2017-02-21T17:58:44Z</cp:lastPrinted>
  <dcterms:created xsi:type="dcterms:W3CDTF">2017-01-30T21:13:26Z</dcterms:created>
  <dcterms:modified xsi:type="dcterms:W3CDTF">2018-02-18T01:18:11Z</dcterms:modified>
</cp:coreProperties>
</file>